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9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7F0F9"/>
    <a:srgbClr val="CDE3A5"/>
    <a:srgbClr val="FFFFCC"/>
    <a:srgbClr val="F7E1F4"/>
    <a:srgbClr val="F1CBC7"/>
    <a:srgbClr val="66FF33"/>
    <a:srgbClr val="F2CFEE"/>
    <a:srgbClr val="FD87A9"/>
    <a:srgbClr val="F793A1"/>
    <a:srgbClr val="F3D0C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020" autoAdjust="0"/>
    <p:restoredTop sz="94660"/>
  </p:normalViewPr>
  <p:slideViewPr>
    <p:cSldViewPr snapToGrid="0">
      <p:cViewPr varScale="1">
        <p:scale>
          <a:sx n="74" d="100"/>
          <a:sy n="74" d="100"/>
        </p:scale>
        <p:origin x="91" y="6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D3227F-B8E1-42A0-9A98-E0D397CD00CE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F7D662A-3A36-44A4-96D6-D1F22AA34B4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43809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2ADAD26-6B58-0C91-BF02-E9A21717B0B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726E5AAB-AC63-E919-24F7-F1EEA8FD361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2330637-6A48-08C4-7A11-1F7D9AC72E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84C202B-4789-D2C5-7DBA-C1995E3446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E315E78-09C6-0D38-533A-AE23FBC2B8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43690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7E92666-D9E1-2A60-F8B6-7A0BD1E9A7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8013C86-8DFD-FC70-1821-35FA04286A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F21C723-B1C8-18EF-02CB-D00E157D34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6D21EBE-AD45-CBB3-FBFD-0E4FBC2C61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95D74D8-537F-5244-2D57-AEAFCF05B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8148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2A58440-FF56-8D98-BDA0-40D6A599E2D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126D6FA-6AFF-7471-B9F5-AD539ECFFFB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930C7D9-B554-0A78-8F98-D1EDA9745F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84EAB8F-9E98-2576-464D-849D21EA0A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802AB71-267C-C31A-39E8-43DFD017B7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4380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55FCCA2-BA3A-FF7F-E4DE-7ED4A0BD03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9A37E07-ABF1-334B-42B5-3F5A2A6F7F8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EB6AFB-5841-4970-DFC9-E52979B8EB0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84BD6C-DD67-FE5F-71EE-E648762858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F2159EA-92D9-4AFD-FD3C-123C33E7C8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13240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F699366-687D-C001-E0B7-1E5D0A1255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64EBFC1-8ECB-A4F6-243D-E2CB7416A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988AB90-6214-9B77-6963-E2A0033EF3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C0F6732-9B0F-BB33-6079-7CFDE1F0EBE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B396CF7-C65D-EBD1-4738-75C2BEEBD8D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05768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9DC7AC1-791F-4148-7158-627E7B0559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9317ACF-3D6F-F2DF-0508-0B340E74A5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CD0673EF-30E9-C3B1-DA30-27BB8AD16A1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29CB926-64FA-0E43-3E38-F7392EA480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D765B0F-FDD4-AF7F-C24C-684D317DED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6143EEA-B584-CA3A-BF73-EB99ED29D4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61558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46B975-BCB5-412D-87ED-DFE36561FF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CCA7ACAC-E2F3-4CE5-3813-AFE6D3EA239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CA01605-EB64-1DDF-4FF1-8F93187BA6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403C67FB-3B53-6697-1C72-C90CF35BA9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19F10467-5D56-0472-3B8F-CAFAB2803CC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9947C2C-E131-B1FF-6BF7-194B208D5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2DAD53ED-920B-9270-34D6-48CDC93B90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18072815-0AF2-A6DF-7FC0-073E51B655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9905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FA9D1C8-898A-B25B-5D78-DC34B1ABE9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2E0BD8E-BF24-05E4-88B0-CB330AFFDD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26EDA26-DD62-C319-366A-5EB313A2C3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D5371F08-F41F-78F1-81D6-42EDB04DB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5776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A87CC08E-5BE0-9C6D-4B66-F1DC5476FE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666ABFE6-2327-DBDB-281F-DE549FFF97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AE4B73D2-DEC7-AFCA-865D-E9C23A0F78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86661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E85582-829D-63C1-6D2E-2DFC3666A86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4A613F-01DB-251B-3DC8-E7F03CACFD2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5337597E-D018-0CD6-92DB-4A4358EE2BB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B341902-AC32-BC7C-2EA9-1946BEE1F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EC13E81-2D65-6A1B-419F-7F9E32011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1E26F97-A138-563A-A1A2-AA11AD2DD7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996991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27A171A-C1A7-DC6C-625C-4BF03635A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0F4A95B-88D3-C74B-7907-81616916C41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444896CE-158D-CFA5-E3F0-D0F14646A1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3B8DBED-3DE4-7753-1CEE-43FEE3929D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20E11CD-7730-3779-1BAD-A49BD4B06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3656C18-7064-D021-485F-FBE363B048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925469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5321953-6930-6B46-7792-692D34A629D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2E34B6F-40F9-A191-7FDA-1BCF210E3D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BD397F4-61BE-8E70-78C2-C23BE5FE218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87BF51A-23E9-4221-80A7-07E89EFFD122}" type="datetimeFigureOut">
              <a:rPr kumimoji="1" lang="ja-JP" altLang="en-US" smtClean="0"/>
              <a:t>2026/3/2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172CB66-47F9-4CE4-CD01-B3E2CD345B7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982CA156-17BD-BBB0-BB6F-2B0502A191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609AC5EA-7C24-4209-BDA7-A8BA6D3E0DC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70319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FC2BBE7-3F7F-D1AC-640F-1DD4E4DBD93E}"/>
              </a:ext>
            </a:extLst>
          </p:cNvPr>
          <p:cNvSpPr txBox="1"/>
          <p:nvPr/>
        </p:nvSpPr>
        <p:spPr>
          <a:xfrm>
            <a:off x="1676401" y="511214"/>
            <a:ext cx="9753600" cy="58477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3200" dirty="0">
                <a:latin typeface="Britannic Bold" panose="020B0903060703020204" pitchFamily="34" charset="0"/>
              </a:rPr>
              <a:t>Full-text assessed studies and reasons for exclusion</a:t>
            </a:r>
            <a:endParaRPr lang="ja-JP" altLang="en-US" sz="3200" dirty="0">
              <a:latin typeface="Britannic Bold" panose="020B0903060703020204" pitchFamily="34" charset="0"/>
            </a:endParaRPr>
          </a:p>
        </p:txBody>
      </p:sp>
      <p:graphicFrame>
        <p:nvGraphicFramePr>
          <p:cNvPr id="3" name="表 2">
            <a:extLst>
              <a:ext uri="{FF2B5EF4-FFF2-40B4-BE49-F238E27FC236}">
                <a16:creationId xmlns:a16="http://schemas.microsoft.com/office/drawing/2014/main" id="{FCC3AEE8-CCA9-67E9-082B-48C593B92CE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01880460"/>
              </p:ext>
            </p:extLst>
          </p:nvPr>
        </p:nvGraphicFramePr>
        <p:xfrm>
          <a:off x="616527" y="1420090"/>
          <a:ext cx="11125200" cy="4634308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494911">
                  <a:extLst>
                    <a:ext uri="{9D8B030D-6E8A-4147-A177-3AD203B41FA5}">
                      <a16:colId xmlns:a16="http://schemas.microsoft.com/office/drawing/2014/main" val="88249244"/>
                    </a:ext>
                  </a:extLst>
                </a:gridCol>
                <a:gridCol w="1615799">
                  <a:extLst>
                    <a:ext uri="{9D8B030D-6E8A-4147-A177-3AD203B41FA5}">
                      <a16:colId xmlns:a16="http://schemas.microsoft.com/office/drawing/2014/main" val="215612627"/>
                    </a:ext>
                  </a:extLst>
                </a:gridCol>
                <a:gridCol w="1077342">
                  <a:extLst>
                    <a:ext uri="{9D8B030D-6E8A-4147-A177-3AD203B41FA5}">
                      <a16:colId xmlns:a16="http://schemas.microsoft.com/office/drawing/2014/main" val="4176781641"/>
                    </a:ext>
                  </a:extLst>
                </a:gridCol>
                <a:gridCol w="1319194">
                  <a:extLst>
                    <a:ext uri="{9D8B030D-6E8A-4147-A177-3AD203B41FA5}">
                      <a16:colId xmlns:a16="http://schemas.microsoft.com/office/drawing/2014/main" val="742774356"/>
                    </a:ext>
                  </a:extLst>
                </a:gridCol>
                <a:gridCol w="1431693">
                  <a:extLst>
                    <a:ext uri="{9D8B030D-6E8A-4147-A177-3AD203B41FA5}">
                      <a16:colId xmlns:a16="http://schemas.microsoft.com/office/drawing/2014/main" val="1268693280"/>
                    </a:ext>
                  </a:extLst>
                </a:gridCol>
                <a:gridCol w="897027">
                  <a:extLst>
                    <a:ext uri="{9D8B030D-6E8A-4147-A177-3AD203B41FA5}">
                      <a16:colId xmlns:a16="http://schemas.microsoft.com/office/drawing/2014/main" val="3026390465"/>
                    </a:ext>
                  </a:extLst>
                </a:gridCol>
                <a:gridCol w="1469834">
                  <a:extLst>
                    <a:ext uri="{9D8B030D-6E8A-4147-A177-3AD203B41FA5}">
                      <a16:colId xmlns:a16="http://schemas.microsoft.com/office/drawing/2014/main" val="2421123181"/>
                    </a:ext>
                  </a:extLst>
                </a:gridCol>
                <a:gridCol w="2154382">
                  <a:extLst>
                    <a:ext uri="{9D8B030D-6E8A-4147-A177-3AD203B41FA5}">
                      <a16:colId xmlns:a16="http://schemas.microsoft.com/office/drawing/2014/main" val="1587300530"/>
                    </a:ext>
                  </a:extLst>
                </a:gridCol>
                <a:gridCol w="665018">
                  <a:extLst>
                    <a:ext uri="{9D8B030D-6E8A-4147-A177-3AD203B41FA5}">
                      <a16:colId xmlns:a16="http://schemas.microsoft.com/office/drawing/2014/main" val="828394389"/>
                    </a:ext>
                  </a:extLst>
                </a:gridCol>
              </a:tblGrid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.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irst Author (Year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udy Typ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therapy Contex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riting Evide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ecision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ason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OI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ourc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2770042188"/>
                  </a:ext>
                </a:extLst>
              </a:tr>
              <a:tr h="540761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en (2022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writing assessmen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rect writing evaluation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038/s41408-022-00629-1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1422493574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elapu</a:t>
                      </a: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2018)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inical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MSE writing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uctured writing task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056/NEJMoa170744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3927441177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ensato (2022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sgraphi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plicit dysgraphi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212/WNL.000000000020003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2955958197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nny (2024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petitive writing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riting abnormality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002/ajh.2700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2400025876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eenbaum (2021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iew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therapy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andwriting chang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riting mention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111/bcp.14403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2871616715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ronski (2025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iew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therapy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sgraphia 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evant discussion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016/j.jneuroim.2025.578717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2518494196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lazzo (2024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iew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therapy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ysgraphia cascad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chanistic relevanc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390/brainsci14121220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857996302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eischer (2024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iew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mmunotherapy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riting difficulties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direct releva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136/jitc-2024-009174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2825839150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halabi (2022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iew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phasia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orting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nguage overlap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3389/fonc.2022.836452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1645074709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st (2018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iew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nguage disturbanc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upporting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lated symptom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007/s40263-018-0582-9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3149839855"/>
                  </a:ext>
                </a:extLst>
              </a:tr>
              <a:tr h="540761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ntanelli (2023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e series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rontal dysfunction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cluded (manual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 indexed with writing terms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007/s10072-023-06841-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anual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965456865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udwig (2023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iew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writing description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016/S1470-2045(23)00159-6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3295054086"/>
                  </a:ext>
                </a:extLst>
              </a:tr>
              <a:tr h="290296"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</a:t>
                      </a:r>
                      <a:endParaRPr lang="en-US" altLang="ja-JP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rudno (2019)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iew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R-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xcluded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writing-specific content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.1016/j.blre.2018.11.002</a:t>
                      </a:r>
                      <a:endParaRPr lang="en-US" sz="105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tc>
                  <a:txBody>
                    <a:bodyPr/>
                    <a:lstStyle/>
                    <a:p>
                      <a:pPr algn="ctr" fontAlgn="b">
                        <a:buNone/>
                      </a:pPr>
                      <a:r>
                        <a:rPr lang="en-US" sz="105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tabase</a:t>
                      </a:r>
                      <a:endParaRPr lang="en-US" sz="105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ＭＳ Ｐゴシック" panose="020B0600070205080204" pitchFamily="50" charset="-128"/>
                        <a:cs typeface="Arial" panose="020B0604020202020204" pitchFamily="34" charset="0"/>
                      </a:endParaRPr>
                    </a:p>
                  </a:txBody>
                  <a:tcPr marL="4873" marR="4873" marT="4873" marB="0" anchor="ctr"/>
                </a:tc>
                <a:extLst>
                  <a:ext uri="{0D108BD9-81ED-4DB2-BD59-A6C34878D82A}">
                    <a16:rowId xmlns:a16="http://schemas.microsoft.com/office/drawing/2014/main" val="262118879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5615165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0</TotalTime>
  <Words>255</Words>
  <Application>Microsoft Office PowerPoint</Application>
  <PresentationFormat>ワイド画面</PresentationFormat>
  <Paragraphs>1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Britannic Bold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akeo Shimasaki</dc:creator>
  <cp:lastModifiedBy>Takeo Shimasaki</cp:lastModifiedBy>
  <cp:revision>46</cp:revision>
  <dcterms:created xsi:type="dcterms:W3CDTF">2025-12-30T00:16:26Z</dcterms:created>
  <dcterms:modified xsi:type="dcterms:W3CDTF">2026-03-27T00:59:04Z</dcterms:modified>
</cp:coreProperties>
</file>